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8306F7-3076-432A-BF72-023CABE39E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405468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B29F7-E7F6-41DE-A843-426B13D350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40546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40546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4DEEE-CEBC-4F9D-AB20-01531E9D3B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90512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90512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40546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40546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40546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F425F4-FB33-4561-91CD-9B7B550BC9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0B560975-8740-46F7-940E-BBB789F7B5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90512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AF453A85-A908-43BA-A404-4D409C548F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F0E6C310-7847-4BE2-911B-5BD50B55F0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90512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738B99A0-FE55-46EF-BA3C-D088E2E30F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2B70DE10-258B-4953-BB3E-E57282CD6F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91960"/>
            <a:ext cx="8229600" cy="6419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6F9D058E-0BB7-4579-97EA-796C68DCB7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90512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40546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1F66FD38-ACEE-4B0B-A774-3BF6D36F26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90512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74E20-8C20-424B-93FB-F91A9DDA3D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40546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9FECFED9-8F2A-43FD-9A5F-A1DE0E4EBE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405468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31C7731C-E06F-4516-9AEF-DDFCAF11EB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405468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01ED2D52-A539-4FC7-9FFA-D1E5566C9C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40546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40546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6CA90317-4DB2-4A31-84F3-8FE85BF2302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90512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90512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40546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40546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40546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F3C533AE-11A1-4A98-8608-6BB98490345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31A86B-6A63-43FB-871E-FB0765BFEE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90512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69409B-28DE-46DD-98D9-003EABC9A0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A92EC-426D-4266-B3C0-DE8EB3A772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91960"/>
            <a:ext cx="8229600" cy="6419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9DAF8-872A-458B-ABF1-27ACE959E4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90512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40546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3F34F-D229-4F7B-BBB5-B9C1030FE1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40546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5BD6C1-39CF-4111-BA45-B4A1B0158A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90512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405468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E1B648-9704-44E8-88E0-7E7B778A6E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91960"/>
            <a:ext cx="8229600" cy="13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90512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ffcc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ffffff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ffcc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ffffff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ffcc00"/>
              </a:buClr>
              <a:buSzPct val="80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ffffff"/>
              </a:buClr>
              <a:buSzPct val="80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ffffff"/>
              </a:buClr>
              <a:buSzPct val="80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8D4FE9-D09E-4D29-96B0-18BAC3B084FB}" type="slidenum">
              <a:rPr b="0" lang="en-US" sz="14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1996920"/>
            <a:ext cx="7772400" cy="1432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85840" y="2803680"/>
            <a:ext cx="1440" cy="3035160"/>
          </a:xfrm>
          <a:custGeom>
            <a:avLst/>
            <a:gdLst/>
            <a:ahLst/>
            <a:rect l="l" t="t" r="r" b="b"/>
            <a:pathLst>
              <a:path w="0" h="1912">
                <a:moveTo>
                  <a:pt x="0" y="0"/>
                </a:moveTo>
                <a:lnTo>
                  <a:pt x="0" y="6"/>
                </a:lnTo>
                <a:lnTo>
                  <a:pt x="0" y="6"/>
                </a:lnTo>
                <a:lnTo>
                  <a:pt x="0" y="60"/>
                </a:lnTo>
                <a:lnTo>
                  <a:pt x="0" y="1912"/>
                </a:lnTo>
                <a:lnTo>
                  <a:pt x="0" y="191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6bba2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ftr" idx="4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Num" idx="5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4B742C-4547-47D6-99F8-3CFFB3060E62}" type="slidenum">
              <a:rPr b="0" lang="en-US" sz="14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6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2222640" y="990720"/>
            <a:ext cx="43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223360" y="3657600"/>
            <a:ext cx="5842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urine 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D36 KO 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rot="16200000">
            <a:off x="977040" y="4383720"/>
            <a:ext cx="1274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hagocytic Index (%)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rot="16200000">
            <a:off x="984960" y="1786680"/>
            <a:ext cx="1274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hagocytic Index (%)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6" name=""/>
          <p:cNvGrpSpPr/>
          <p:nvPr/>
        </p:nvGrpSpPr>
        <p:grpSpPr>
          <a:xfrm>
            <a:off x="2300040" y="5410080"/>
            <a:ext cx="3324600" cy="137520"/>
            <a:chOff x="2300040" y="5410080"/>
            <a:chExt cx="3324600" cy="137520"/>
          </a:xfrm>
        </p:grpSpPr>
        <p:sp>
          <p:nvSpPr>
            <p:cNvPr id="87" name=""/>
            <p:cNvSpPr/>
            <p:nvPr/>
          </p:nvSpPr>
          <p:spPr>
            <a:xfrm>
              <a:off x="2300040" y="5410080"/>
              <a:ext cx="1152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NI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755800" y="5410080"/>
              <a:ext cx="22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G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265560" y="5410080"/>
              <a:ext cx="22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G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822840" y="5410080"/>
              <a:ext cx="247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G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4310280" y="5410080"/>
              <a:ext cx="247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G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843800" y="5410080"/>
              <a:ext cx="247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G3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5376960" y="5410080"/>
              <a:ext cx="247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G4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4" name=""/>
          <p:cNvSpPr/>
          <p:nvPr/>
        </p:nvSpPr>
        <p:spPr>
          <a:xfrm>
            <a:off x="2719440" y="5251320"/>
            <a:ext cx="307800" cy="90720"/>
          </a:xfrm>
          <a:prstGeom prst="rect">
            <a:avLst/>
          </a:prstGeom>
          <a:solidFill>
            <a:srgbClr val="0101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724120" y="5256360"/>
            <a:ext cx="308160" cy="91800"/>
          </a:xfrm>
          <a:prstGeom prst="rect">
            <a:avLst/>
          </a:prstGeom>
          <a:solidFill>
            <a:srgbClr val="969696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241800" y="5262480"/>
            <a:ext cx="307800" cy="79560"/>
          </a:xfrm>
          <a:prstGeom prst="rect">
            <a:avLst/>
          </a:prstGeom>
          <a:solidFill>
            <a:srgbClr val="96969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244680" y="5267160"/>
            <a:ext cx="309600" cy="81000"/>
          </a:xfrm>
          <a:prstGeom prst="rect">
            <a:avLst/>
          </a:pr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767040" y="5297400"/>
            <a:ext cx="317520" cy="5076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297320" y="4119480"/>
            <a:ext cx="309600" cy="12286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4819680" y="4351320"/>
            <a:ext cx="309600" cy="99684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342040" y="4643280"/>
            <a:ext cx="307800" cy="7048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flipV="1">
            <a:off x="2351160" y="5336640"/>
            <a:ext cx="1440" cy="11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327400" y="5337000"/>
            <a:ext cx="55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flipV="1">
            <a:off x="2873520" y="5246280"/>
            <a:ext cx="1440" cy="97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849400" y="5246640"/>
            <a:ext cx="5580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395520" y="5267160"/>
            <a:ext cx="180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371760" y="5267160"/>
            <a:ext cx="5580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V="1">
            <a:off x="3925800" y="5246280"/>
            <a:ext cx="1800" cy="507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902040" y="5246640"/>
            <a:ext cx="5544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V="1">
            <a:off x="4448160" y="3787560"/>
            <a:ext cx="1440" cy="3315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4424400" y="3787920"/>
            <a:ext cx="554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flipV="1">
            <a:off x="4970520" y="4269960"/>
            <a:ext cx="1440" cy="810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946760" y="4270320"/>
            <a:ext cx="5544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flipV="1">
            <a:off x="5492880" y="4541760"/>
            <a:ext cx="1440" cy="1015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5468760" y="4541760"/>
            <a:ext cx="5580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2098800" y="3586320"/>
            <a:ext cx="1440" cy="1761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2066760" y="5348160"/>
            <a:ext cx="320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066760" y="5156280"/>
            <a:ext cx="32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066760" y="4954680"/>
            <a:ext cx="32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2066760" y="4764240"/>
            <a:ext cx="32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066760" y="4562640"/>
            <a:ext cx="32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066760" y="4370400"/>
            <a:ext cx="32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2066760" y="4170240"/>
            <a:ext cx="320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2066760" y="3978360"/>
            <a:ext cx="32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2066760" y="3776760"/>
            <a:ext cx="32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2066760" y="3586320"/>
            <a:ext cx="32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098800" y="5348160"/>
            <a:ext cx="36622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flipV="1">
            <a:off x="2098800" y="534780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flipV="1">
            <a:off x="2620800" y="5347800"/>
            <a:ext cx="180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flipV="1">
            <a:off x="3143160" y="5347800"/>
            <a:ext cx="180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V="1">
            <a:off x="3665520" y="534780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flipV="1">
            <a:off x="4194000" y="5347800"/>
            <a:ext cx="180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flipV="1">
            <a:off x="4716360" y="5347800"/>
            <a:ext cx="180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flipV="1">
            <a:off x="5238720" y="534780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flipV="1">
            <a:off x="5761080" y="534780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963080" y="52671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1963080" y="507528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1907280" y="487512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1907280" y="468324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1907280" y="448164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1907280" y="429084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907280" y="408924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1907280" y="389736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907280" y="36972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1907280" y="350532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5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2200320" y="2170080"/>
            <a:ext cx="307800" cy="692280"/>
          </a:xfrm>
          <a:prstGeom prst="rect">
            <a:avLst/>
          </a:pr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716200" y="2195640"/>
            <a:ext cx="316080" cy="662040"/>
          </a:xfrm>
          <a:prstGeom prst="rect">
            <a:avLst/>
          </a:prstGeom>
          <a:solidFill>
            <a:srgbClr val="96969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719440" y="2200320"/>
            <a:ext cx="317520" cy="662040"/>
          </a:xfrm>
          <a:prstGeom prst="rect">
            <a:avLst/>
          </a:pr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3243240" y="2116080"/>
            <a:ext cx="309600" cy="741600"/>
          </a:xfrm>
          <a:prstGeom prst="rect">
            <a:avLst/>
          </a:prstGeom>
          <a:solidFill>
            <a:srgbClr val="96969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3247920" y="2120760"/>
            <a:ext cx="308160" cy="741600"/>
          </a:xfrm>
          <a:prstGeom prst="rect">
            <a:avLst/>
          </a:pr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3767040" y="2381400"/>
            <a:ext cx="317520" cy="48096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4295880" y="1197000"/>
            <a:ext cx="309600" cy="166536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816440" y="1719360"/>
            <a:ext cx="316080" cy="11430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5343480" y="1378080"/>
            <a:ext cx="309600" cy="14842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354400" y="2170080"/>
            <a:ext cx="144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330280" y="2170080"/>
            <a:ext cx="5580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2873520" y="2009520"/>
            <a:ext cx="1440" cy="190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849400" y="2009880"/>
            <a:ext cx="57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flipV="1">
            <a:off x="3402000" y="1990440"/>
            <a:ext cx="1440" cy="1299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378240" y="1990800"/>
            <a:ext cx="57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flipV="1">
            <a:off x="3922560" y="2199960"/>
            <a:ext cx="1800" cy="1810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897360" y="2200320"/>
            <a:ext cx="57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 flipV="1">
            <a:off x="4449600" y="1157400"/>
            <a:ext cx="1800" cy="396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4425840" y="1157400"/>
            <a:ext cx="57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 flipV="1">
            <a:off x="4970520" y="1208160"/>
            <a:ext cx="1440" cy="5112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4944960" y="1208160"/>
            <a:ext cx="57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V="1">
            <a:off x="5497560" y="1267920"/>
            <a:ext cx="1440" cy="109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5473800" y="1268280"/>
            <a:ext cx="5688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093760" y="966960"/>
            <a:ext cx="1800" cy="1895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2062080" y="2862360"/>
            <a:ext cx="316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2062080" y="2622600"/>
            <a:ext cx="316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2062080" y="2390760"/>
            <a:ext cx="316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2062080" y="2151000"/>
            <a:ext cx="316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2062080" y="1919160"/>
            <a:ext cx="316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062080" y="1679400"/>
            <a:ext cx="316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2062080" y="1438200"/>
            <a:ext cx="316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2062080" y="1208160"/>
            <a:ext cx="316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2062080" y="966960"/>
            <a:ext cx="316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093760" y="2862360"/>
            <a:ext cx="36640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V="1">
            <a:off x="2093760" y="2862360"/>
            <a:ext cx="180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flipV="1">
            <a:off x="2614680" y="2862360"/>
            <a:ext cx="144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 flipV="1">
            <a:off x="3141720" y="2862360"/>
            <a:ext cx="144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flipV="1">
            <a:off x="3662280" y="2862360"/>
            <a:ext cx="180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 flipV="1">
            <a:off x="4191120" y="2862360"/>
            <a:ext cx="144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 flipV="1">
            <a:off x="4710240" y="2862360"/>
            <a:ext cx="144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flipV="1">
            <a:off x="5238720" y="2862360"/>
            <a:ext cx="144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 flipV="1">
            <a:off x="5757840" y="2862360"/>
            <a:ext cx="144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1955160" y="278280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1897920" y="25416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897920" y="231156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1897920" y="20700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1897920" y="183996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1842120" y="159876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1842120" y="135720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1842120" y="112716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4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1842120" y="88740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6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197" name=""/>
          <p:cNvGrpSpPr/>
          <p:nvPr/>
        </p:nvGrpSpPr>
        <p:grpSpPr>
          <a:xfrm>
            <a:off x="2298240" y="2895480"/>
            <a:ext cx="3324600" cy="137520"/>
            <a:chOff x="2298240" y="2895480"/>
            <a:chExt cx="3324600" cy="137520"/>
          </a:xfrm>
        </p:grpSpPr>
        <p:sp>
          <p:nvSpPr>
            <p:cNvPr id="198" name=""/>
            <p:cNvSpPr/>
            <p:nvPr/>
          </p:nvSpPr>
          <p:spPr>
            <a:xfrm>
              <a:off x="2298240" y="2895480"/>
              <a:ext cx="1152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NI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2754000" y="2895480"/>
              <a:ext cx="22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G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3263760" y="2895480"/>
              <a:ext cx="22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G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3821040" y="2895480"/>
              <a:ext cx="247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G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4308480" y="2895480"/>
              <a:ext cx="247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G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4842000" y="2895480"/>
              <a:ext cx="247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G3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5375160" y="2895480"/>
              <a:ext cx="247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G4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05" name=""/>
          <p:cNvSpPr/>
          <p:nvPr/>
        </p:nvSpPr>
        <p:spPr>
          <a:xfrm>
            <a:off x="1449360" y="760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1449360" y="3351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723960" y="6416640"/>
            <a:ext cx="87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3-13T15:39:10Z</dcterms:created>
  <dc:creator>Jessica</dc:creator>
  <dc:description/>
  <dc:language>en-US</dc:language>
  <cp:lastModifiedBy>Kevin Kain</cp:lastModifiedBy>
  <cp:lastPrinted>2007-01-23T16:26:19Z</cp:lastPrinted>
  <dcterms:modified xsi:type="dcterms:W3CDTF">2007-01-24T19:02:39Z</dcterms:modified>
  <cp:revision>177</cp:revision>
  <dc:subject/>
  <dc:title>Slide 1</dc:title>
</cp:coreProperties>
</file>